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E9FA1C-3F81-479E-BD2E-FF9F9E7870C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0EF71-9EBE-465E-9DE4-3611A6E9AB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11350-52AE-45AA-A1F0-4C06FC5AD4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3CC75-CFD9-4265-9A34-09628E5625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2298D-B0D7-4359-AFB2-06395AC1BC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3C891-7D3E-4A62-921A-956D4E8D21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0A1BF-A1B5-491D-B4BE-DC028C08CA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3F8D3E-AACC-4354-8C90-A09EB96532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D12F4-17BF-41FA-BDD4-C43C94EF8A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2DE84-4D76-417E-BC47-6C8DACA12D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0E289-3B3A-44CD-BF9C-1F2F074C15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F0277-A15F-4C60-8066-BB27BAECBF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B5E5354-4C7F-400A-B598-565BB7C20BF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286000" y="189000"/>
            <a:ext cx="4572000" cy="53942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539640" y="5589720"/>
            <a:ext cx="8317080" cy="97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- Correlation with weight loss for identified covarying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From the list of 83 genes identified as correlating with weight loss 9 were picked for validation by qRT-PCR. Correlation plots for array data and qRT-PCR data with weight loss are shown. The PCR and array data were scaled to make them comparable and each dataset is plotted against % weight loss. For each dataset the least squares line is also shown.  P-values for the correlations ranged from 0.03 to below 0.01. All genes excepts SGK1 validated the array. Red = PCR; black = array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2157480" y="836640"/>
            <a:ext cx="4827600" cy="31640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539640" y="4221000"/>
            <a:ext cx="8280360" cy="140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 - Correlation of autophagy related genes with SI in cancer cachexi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o investigate the role of autophagy in cancer cachexia the mRNA expression of two autophagy related genes, BNIP3 (S2A) and GABARAPL1 (S2B) were assessed by qRT-PCR in RNA isolated from the rectus abdominis muscle of subjects from centre 1. Correlation with CRP (mg / ml) as a measure of SI was examined as we had found GABARAPL1 correlating with SI in Affymetrix analysis. mRNA levels for both genes showed significant correlation with CRP (mg / ml). The correlation coefficient (R) was 0.57 and regression p-value=0.005 for GABARAPL1 and 0.53 with a p-value of 0.01 for BNIP3. Note that only the BNIP3 expression demonstrated a biologically meaningful relationship with CRP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684360" y="-27000"/>
            <a:ext cx="3890880" cy="671508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4788000" y="765000"/>
            <a:ext cx="3960720" cy="183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 - Gene networks involving weight loss correlating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Using the Ingenuity database we examined the list of weight loss correlating genes for gene interactions. This analysis revealed networks involving calmodulin (Figure S3A) and IL-6 (Figure S3B). Red symbols represent genes upregulated in the WL group and blue symbols represent those downregulated in the WL group by Affymetrix analysi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324000" y="44280"/>
            <a:ext cx="4512960" cy="668844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>
            <a:off x="4643280" y="620640"/>
            <a:ext cx="4105440" cy="155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Figure S4 - Enriched transcription factor binding sites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Upstream promoters of the WL and SI correlating genes as well as all genes expressed in muscle were scanned as detailed in methods. The Z score for each transcription factor binding site (TFBS) was used to generate a heatmap showing TFBS enrichment in each gene list. WL = WL correlating gene list; SI = CRP correlating genelist; Expr = expressed in muscle (from Affymetix MAS5 P/A calls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08T18:14:47Z</dcterms:created>
  <dc:creator>Iain Gallagher</dc:creator>
  <dc:description/>
  <dc:language>en-US</dc:language>
  <cp:lastModifiedBy>Iain Gallagher</cp:lastModifiedBy>
  <dcterms:modified xsi:type="dcterms:W3CDTF">2010-01-08T18:21:05Z</dcterms:modified>
  <cp:revision>4</cp:revision>
  <dc:subject/>
  <dc:title>Slide 1</dc:title>
</cp:coreProperties>
</file>